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8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xlsx" ContentType="application/vnd.openxmlformats-officedocument.spreadsheetml.sheet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6C7FD-DC79-4185-B001-0558E06519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63272-07DB-4358-A5F6-5A692BBA12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283ED5-F61B-4585-9C8B-952AF8DC76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D8470-F7C4-4BEC-8306-BB0FB08752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65AF7-4518-48B1-A4A0-A8256F53F2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F7D0E-757D-461D-8B42-442AC5FBFD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637A5-E4C6-4354-A062-7BB23FEE49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7C9F59-7991-4E1E-8A65-0CA76EC219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AC96D-2893-4DE1-9575-3DB3CF3144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43EB8-75EC-4D95-8074-21135D0FC1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290B8-3D56-4AC1-B687-9902796D71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D8502-39E2-4A31-AFC9-0B61C45F89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5C5215-F45F-426C-9BE6-B308B0AA2C6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package" Target="../embeddings/oleObject7.xlsx"/><Relationship Id="rId14" Type="http://schemas.openxmlformats.org/officeDocument/2006/relationships/image" Target="../media/image7.wmf"/><Relationship Id="rId15" Type="http://schemas.openxmlformats.org/officeDocument/2006/relationships/package" Target="../embeddings/oleObject8.xlsx"/><Relationship Id="rId16" Type="http://schemas.openxmlformats.org/officeDocument/2006/relationships/image" Target="../media/image8.wmf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85840" y="1165320"/>
          <a:ext cx="1955880" cy="1879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85840" y="1165320"/>
                    <a:ext cx="1955880" cy="187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290520" y="3057480"/>
          <a:ext cx="1951200" cy="1879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90520" y="3057480"/>
                    <a:ext cx="1951200" cy="187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2433600" y="1179360"/>
          <a:ext cx="2909880" cy="187992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433600" y="1179360"/>
                    <a:ext cx="2909880" cy="1879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2430360" y="3075120"/>
          <a:ext cx="2909880" cy="187956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430360" y="3075120"/>
                    <a:ext cx="2909880" cy="187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"/>
          <p:cNvSpPr/>
          <p:nvPr/>
        </p:nvSpPr>
        <p:spPr>
          <a:xfrm>
            <a:off x="750960" y="1461960"/>
            <a:ext cx="24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270080" y="1817640"/>
            <a:ext cx="260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712880" y="164628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/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8440" y="28440"/>
            <a:ext cx="68295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data 6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orphometric analysis of “central” and “peripheral” IMF mitochondria in gastrocnemius muscle of N, HFD, and HFD+T2 rats (n=3). Mean values and frequency distributions were determined for surface area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Feret’s index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Bars labeled with dissimilar letters are significantly different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&lt;0.05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58"/>
          <p:cNvSpPr/>
          <p:nvPr/>
        </p:nvSpPr>
        <p:spPr>
          <a:xfrm>
            <a:off x="76320" y="112248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243000" y="5110200"/>
          <a:ext cx="1992240" cy="18781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243000" y="5110200"/>
                    <a:ext cx="1992240" cy="187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"/>
          <p:cNvGraphicFramePr/>
          <p:nvPr/>
        </p:nvGraphicFramePr>
        <p:xfrm>
          <a:off x="252360" y="7043760"/>
          <a:ext cx="1986120" cy="18795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7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52360" y="7043760"/>
                    <a:ext cx="1986120" cy="187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8" name=""/>
          <p:cNvGraphicFramePr/>
          <p:nvPr/>
        </p:nvGraphicFramePr>
        <p:xfrm>
          <a:off x="2414520" y="5106960"/>
          <a:ext cx="2909880" cy="1879560"/>
        </p:xfrm>
        <a:graphic>
          <a:graphicData uri="http://schemas.openxmlformats.org/presentationml/2006/ole">
            <p:oleObj progId="Excel.Sheet.12" r:id="rId13" spid="">
              <p:embed/>
              <p:pic>
                <p:nvPicPr>
                  <p:cNvPr id="59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2414520" y="5106960"/>
                    <a:ext cx="2909880" cy="187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0" name=""/>
          <p:cNvGraphicFramePr/>
          <p:nvPr/>
        </p:nvGraphicFramePr>
        <p:xfrm>
          <a:off x="2419200" y="7008840"/>
          <a:ext cx="2803680" cy="1878120"/>
        </p:xfrm>
        <a:graphic>
          <a:graphicData uri="http://schemas.openxmlformats.org/presentationml/2006/ole">
            <p:oleObj progId="Excel.Sheet.12" r:id="rId15" spid="">
              <p:embed/>
              <p:pic>
                <p:nvPicPr>
                  <p:cNvPr id="61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2419200" y="7008840"/>
                    <a:ext cx="2803680" cy="187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2" name=""/>
          <p:cNvSpPr/>
          <p:nvPr/>
        </p:nvSpPr>
        <p:spPr>
          <a:xfrm>
            <a:off x="750960" y="5535720"/>
            <a:ext cx="24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270080" y="5748480"/>
            <a:ext cx="260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779480" y="5529240"/>
            <a:ext cx="260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8"/>
          <p:cNvSpPr/>
          <p:nvPr/>
        </p:nvSpPr>
        <p:spPr>
          <a:xfrm>
            <a:off x="76320" y="505620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-456840" y="3887280"/>
            <a:ext cx="1447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Arial"/>
              </a:rPr>
              <a:t>mean area (nm</a:t>
            </a:r>
            <a:r>
              <a:rPr b="1" lang="it-IT" sz="7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it-IT" sz="7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-456840" y="1988640"/>
            <a:ext cx="1447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700" spc="-1" strike="noStrike">
                <a:solidFill>
                  <a:srgbClr val="000000"/>
                </a:solidFill>
                <a:latin typeface="Arial"/>
              </a:rPr>
              <a:t>mean area (nm</a:t>
            </a:r>
            <a:r>
              <a:rPr b="1" lang="it-IT" sz="7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it-IT" sz="7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717480" y="1736640"/>
            <a:ext cx="339840" cy="874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230480" y="2073240"/>
            <a:ext cx="339480" cy="544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757520" y="1920960"/>
            <a:ext cx="339480" cy="6872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719280" y="3905280"/>
            <a:ext cx="339480" cy="596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239840" y="3965400"/>
            <a:ext cx="339840" cy="540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755720" y="3849840"/>
            <a:ext cx="339840" cy="645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706320" y="5784840"/>
            <a:ext cx="339840" cy="773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227240" y="5994360"/>
            <a:ext cx="339480" cy="566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755720" y="5802480"/>
            <a:ext cx="339840" cy="760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09560" y="7813800"/>
            <a:ext cx="339840" cy="680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230480" y="7864560"/>
            <a:ext cx="339480" cy="620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755720" y="7704000"/>
            <a:ext cx="339840" cy="787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SBA</cp:lastModifiedBy>
  <dcterms:modified xsi:type="dcterms:W3CDTF">2018-01-25T12:12:58Z</dcterms:modified>
  <cp:revision>1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